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sldIdLst>
    <p:sldId id="256" r:id="rId2"/>
  </p:sldIdLst>
  <p:sldSz cx="11358563" cy="70246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78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19821" y="1149643"/>
            <a:ext cx="8518922" cy="2445632"/>
          </a:xfrm>
        </p:spPr>
        <p:txBody>
          <a:bodyPr anchor="b"/>
          <a:lstStyle>
            <a:lvl1pPr algn="ctr">
              <a:defRPr sz="559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19821" y="3689588"/>
            <a:ext cx="8518922" cy="1696006"/>
          </a:xfrm>
        </p:spPr>
        <p:txBody>
          <a:bodyPr/>
          <a:lstStyle>
            <a:lvl1pPr marL="0" indent="0" algn="ctr">
              <a:buNone/>
              <a:defRPr sz="2236"/>
            </a:lvl1pPr>
            <a:lvl2pPr marL="425928" indent="0" algn="ctr">
              <a:buNone/>
              <a:defRPr sz="1863"/>
            </a:lvl2pPr>
            <a:lvl3pPr marL="851855" indent="0" algn="ctr">
              <a:buNone/>
              <a:defRPr sz="1677"/>
            </a:lvl3pPr>
            <a:lvl4pPr marL="1277783" indent="0" algn="ctr">
              <a:buNone/>
              <a:defRPr sz="1491"/>
            </a:lvl4pPr>
            <a:lvl5pPr marL="1703710" indent="0" algn="ctr">
              <a:buNone/>
              <a:defRPr sz="1491"/>
            </a:lvl5pPr>
            <a:lvl6pPr marL="2129638" indent="0" algn="ctr">
              <a:buNone/>
              <a:defRPr sz="1491"/>
            </a:lvl6pPr>
            <a:lvl7pPr marL="2555565" indent="0" algn="ctr">
              <a:buNone/>
              <a:defRPr sz="1491"/>
            </a:lvl7pPr>
            <a:lvl8pPr marL="2981493" indent="0" algn="ctr">
              <a:buNone/>
              <a:defRPr sz="1491"/>
            </a:lvl8pPr>
            <a:lvl9pPr marL="3407420" indent="0" algn="ctr">
              <a:buNone/>
              <a:defRPr sz="1491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4388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84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128472" y="374000"/>
            <a:ext cx="2449190" cy="595309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80901" y="374000"/>
            <a:ext cx="7205588" cy="595309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4231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0358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4985" y="1751295"/>
            <a:ext cx="9796761" cy="2922075"/>
          </a:xfrm>
        </p:spPr>
        <p:txBody>
          <a:bodyPr anchor="b"/>
          <a:lstStyle>
            <a:lvl1pPr>
              <a:defRPr sz="559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4985" y="4701013"/>
            <a:ext cx="9796761" cy="1536650"/>
          </a:xfrm>
        </p:spPr>
        <p:txBody>
          <a:bodyPr/>
          <a:lstStyle>
            <a:lvl1pPr marL="0" indent="0">
              <a:buNone/>
              <a:defRPr sz="2236">
                <a:solidFill>
                  <a:schemeClr val="tx1">
                    <a:tint val="75000"/>
                  </a:schemeClr>
                </a:solidFill>
              </a:defRPr>
            </a:lvl1pPr>
            <a:lvl2pPr marL="425928" indent="0">
              <a:buNone/>
              <a:defRPr sz="1863">
                <a:solidFill>
                  <a:schemeClr val="tx1">
                    <a:tint val="75000"/>
                  </a:schemeClr>
                </a:solidFill>
              </a:defRPr>
            </a:lvl2pPr>
            <a:lvl3pPr marL="851855" indent="0">
              <a:buNone/>
              <a:defRPr sz="1677">
                <a:solidFill>
                  <a:schemeClr val="tx1">
                    <a:tint val="75000"/>
                  </a:schemeClr>
                </a:solidFill>
              </a:defRPr>
            </a:lvl3pPr>
            <a:lvl4pPr marL="1277783" indent="0">
              <a:buNone/>
              <a:defRPr sz="1491">
                <a:solidFill>
                  <a:schemeClr val="tx1">
                    <a:tint val="75000"/>
                  </a:schemeClr>
                </a:solidFill>
              </a:defRPr>
            </a:lvl4pPr>
            <a:lvl5pPr marL="1703710" indent="0">
              <a:buNone/>
              <a:defRPr sz="1491">
                <a:solidFill>
                  <a:schemeClr val="tx1">
                    <a:tint val="75000"/>
                  </a:schemeClr>
                </a:solidFill>
              </a:defRPr>
            </a:lvl5pPr>
            <a:lvl6pPr marL="2129638" indent="0">
              <a:buNone/>
              <a:defRPr sz="1491">
                <a:solidFill>
                  <a:schemeClr val="tx1">
                    <a:tint val="75000"/>
                  </a:schemeClr>
                </a:solidFill>
              </a:defRPr>
            </a:lvl6pPr>
            <a:lvl7pPr marL="2555565" indent="0">
              <a:buNone/>
              <a:defRPr sz="1491">
                <a:solidFill>
                  <a:schemeClr val="tx1">
                    <a:tint val="75000"/>
                  </a:schemeClr>
                </a:solidFill>
              </a:defRPr>
            </a:lvl7pPr>
            <a:lvl8pPr marL="2981493" indent="0">
              <a:buNone/>
              <a:defRPr sz="1491">
                <a:solidFill>
                  <a:schemeClr val="tx1">
                    <a:tint val="75000"/>
                  </a:schemeClr>
                </a:solidFill>
              </a:defRPr>
            </a:lvl8pPr>
            <a:lvl9pPr marL="3407420" indent="0">
              <a:buNone/>
              <a:defRPr sz="14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032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80901" y="1869998"/>
            <a:ext cx="4827389" cy="44571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50273" y="1869998"/>
            <a:ext cx="4827389" cy="44571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764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380" y="374000"/>
            <a:ext cx="9796761" cy="135778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381" y="1722025"/>
            <a:ext cx="4805204" cy="843938"/>
          </a:xfrm>
        </p:spPr>
        <p:txBody>
          <a:bodyPr anchor="b"/>
          <a:lstStyle>
            <a:lvl1pPr marL="0" indent="0">
              <a:buNone/>
              <a:defRPr sz="2236" b="1"/>
            </a:lvl1pPr>
            <a:lvl2pPr marL="425928" indent="0">
              <a:buNone/>
              <a:defRPr sz="1863" b="1"/>
            </a:lvl2pPr>
            <a:lvl3pPr marL="851855" indent="0">
              <a:buNone/>
              <a:defRPr sz="1677" b="1"/>
            </a:lvl3pPr>
            <a:lvl4pPr marL="1277783" indent="0">
              <a:buNone/>
              <a:defRPr sz="1491" b="1"/>
            </a:lvl4pPr>
            <a:lvl5pPr marL="1703710" indent="0">
              <a:buNone/>
              <a:defRPr sz="1491" b="1"/>
            </a:lvl5pPr>
            <a:lvl6pPr marL="2129638" indent="0">
              <a:buNone/>
              <a:defRPr sz="1491" b="1"/>
            </a:lvl6pPr>
            <a:lvl7pPr marL="2555565" indent="0">
              <a:buNone/>
              <a:defRPr sz="1491" b="1"/>
            </a:lvl7pPr>
            <a:lvl8pPr marL="2981493" indent="0">
              <a:buNone/>
              <a:defRPr sz="1491" b="1"/>
            </a:lvl8pPr>
            <a:lvl9pPr marL="3407420" indent="0">
              <a:buNone/>
              <a:defRPr sz="149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2381" y="2565963"/>
            <a:ext cx="4805204" cy="377414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750272" y="1722025"/>
            <a:ext cx="4828869" cy="843938"/>
          </a:xfrm>
        </p:spPr>
        <p:txBody>
          <a:bodyPr anchor="b"/>
          <a:lstStyle>
            <a:lvl1pPr marL="0" indent="0">
              <a:buNone/>
              <a:defRPr sz="2236" b="1"/>
            </a:lvl1pPr>
            <a:lvl2pPr marL="425928" indent="0">
              <a:buNone/>
              <a:defRPr sz="1863" b="1"/>
            </a:lvl2pPr>
            <a:lvl3pPr marL="851855" indent="0">
              <a:buNone/>
              <a:defRPr sz="1677" b="1"/>
            </a:lvl3pPr>
            <a:lvl4pPr marL="1277783" indent="0">
              <a:buNone/>
              <a:defRPr sz="1491" b="1"/>
            </a:lvl4pPr>
            <a:lvl5pPr marL="1703710" indent="0">
              <a:buNone/>
              <a:defRPr sz="1491" b="1"/>
            </a:lvl5pPr>
            <a:lvl6pPr marL="2129638" indent="0">
              <a:buNone/>
              <a:defRPr sz="1491" b="1"/>
            </a:lvl6pPr>
            <a:lvl7pPr marL="2555565" indent="0">
              <a:buNone/>
              <a:defRPr sz="1491" b="1"/>
            </a:lvl7pPr>
            <a:lvl8pPr marL="2981493" indent="0">
              <a:buNone/>
              <a:defRPr sz="1491" b="1"/>
            </a:lvl8pPr>
            <a:lvl9pPr marL="3407420" indent="0">
              <a:buNone/>
              <a:defRPr sz="149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750272" y="2565963"/>
            <a:ext cx="4828869" cy="377414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4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4395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2482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381" y="468312"/>
            <a:ext cx="3663432" cy="1639094"/>
          </a:xfrm>
        </p:spPr>
        <p:txBody>
          <a:bodyPr anchor="b"/>
          <a:lstStyle>
            <a:lvl1pPr>
              <a:defRPr sz="298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28868" y="1011425"/>
            <a:ext cx="5750273" cy="4992082"/>
          </a:xfrm>
        </p:spPr>
        <p:txBody>
          <a:bodyPr/>
          <a:lstStyle>
            <a:lvl1pPr>
              <a:defRPr sz="2981"/>
            </a:lvl1pPr>
            <a:lvl2pPr>
              <a:defRPr sz="2608"/>
            </a:lvl2pPr>
            <a:lvl3pPr>
              <a:defRPr sz="2236"/>
            </a:lvl3pPr>
            <a:lvl4pPr>
              <a:defRPr sz="1863"/>
            </a:lvl4pPr>
            <a:lvl5pPr>
              <a:defRPr sz="1863"/>
            </a:lvl5pPr>
            <a:lvl6pPr>
              <a:defRPr sz="1863"/>
            </a:lvl6pPr>
            <a:lvl7pPr>
              <a:defRPr sz="1863"/>
            </a:lvl7pPr>
            <a:lvl8pPr>
              <a:defRPr sz="1863"/>
            </a:lvl8pPr>
            <a:lvl9pPr>
              <a:defRPr sz="186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2381" y="2107406"/>
            <a:ext cx="3663432" cy="3904231"/>
          </a:xfrm>
        </p:spPr>
        <p:txBody>
          <a:bodyPr/>
          <a:lstStyle>
            <a:lvl1pPr marL="0" indent="0">
              <a:buNone/>
              <a:defRPr sz="1491"/>
            </a:lvl1pPr>
            <a:lvl2pPr marL="425928" indent="0">
              <a:buNone/>
              <a:defRPr sz="1304"/>
            </a:lvl2pPr>
            <a:lvl3pPr marL="851855" indent="0">
              <a:buNone/>
              <a:defRPr sz="1118"/>
            </a:lvl3pPr>
            <a:lvl4pPr marL="1277783" indent="0">
              <a:buNone/>
              <a:defRPr sz="932"/>
            </a:lvl4pPr>
            <a:lvl5pPr marL="1703710" indent="0">
              <a:buNone/>
              <a:defRPr sz="932"/>
            </a:lvl5pPr>
            <a:lvl6pPr marL="2129638" indent="0">
              <a:buNone/>
              <a:defRPr sz="932"/>
            </a:lvl6pPr>
            <a:lvl7pPr marL="2555565" indent="0">
              <a:buNone/>
              <a:defRPr sz="932"/>
            </a:lvl7pPr>
            <a:lvl8pPr marL="2981493" indent="0">
              <a:buNone/>
              <a:defRPr sz="932"/>
            </a:lvl8pPr>
            <a:lvl9pPr marL="3407420" indent="0">
              <a:buNone/>
              <a:defRPr sz="93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8968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381" y="468312"/>
            <a:ext cx="3663432" cy="1639094"/>
          </a:xfrm>
        </p:spPr>
        <p:txBody>
          <a:bodyPr anchor="b"/>
          <a:lstStyle>
            <a:lvl1pPr>
              <a:defRPr sz="298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28868" y="1011425"/>
            <a:ext cx="5750273" cy="4992082"/>
          </a:xfrm>
        </p:spPr>
        <p:txBody>
          <a:bodyPr anchor="t"/>
          <a:lstStyle>
            <a:lvl1pPr marL="0" indent="0">
              <a:buNone/>
              <a:defRPr sz="2981"/>
            </a:lvl1pPr>
            <a:lvl2pPr marL="425928" indent="0">
              <a:buNone/>
              <a:defRPr sz="2608"/>
            </a:lvl2pPr>
            <a:lvl3pPr marL="851855" indent="0">
              <a:buNone/>
              <a:defRPr sz="2236"/>
            </a:lvl3pPr>
            <a:lvl4pPr marL="1277783" indent="0">
              <a:buNone/>
              <a:defRPr sz="1863"/>
            </a:lvl4pPr>
            <a:lvl5pPr marL="1703710" indent="0">
              <a:buNone/>
              <a:defRPr sz="1863"/>
            </a:lvl5pPr>
            <a:lvl6pPr marL="2129638" indent="0">
              <a:buNone/>
              <a:defRPr sz="1863"/>
            </a:lvl6pPr>
            <a:lvl7pPr marL="2555565" indent="0">
              <a:buNone/>
              <a:defRPr sz="1863"/>
            </a:lvl7pPr>
            <a:lvl8pPr marL="2981493" indent="0">
              <a:buNone/>
              <a:defRPr sz="1863"/>
            </a:lvl8pPr>
            <a:lvl9pPr marL="3407420" indent="0">
              <a:buNone/>
              <a:defRPr sz="186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2381" y="2107406"/>
            <a:ext cx="3663432" cy="3904231"/>
          </a:xfrm>
        </p:spPr>
        <p:txBody>
          <a:bodyPr/>
          <a:lstStyle>
            <a:lvl1pPr marL="0" indent="0">
              <a:buNone/>
              <a:defRPr sz="1491"/>
            </a:lvl1pPr>
            <a:lvl2pPr marL="425928" indent="0">
              <a:buNone/>
              <a:defRPr sz="1304"/>
            </a:lvl2pPr>
            <a:lvl3pPr marL="851855" indent="0">
              <a:buNone/>
              <a:defRPr sz="1118"/>
            </a:lvl3pPr>
            <a:lvl4pPr marL="1277783" indent="0">
              <a:buNone/>
              <a:defRPr sz="932"/>
            </a:lvl4pPr>
            <a:lvl5pPr marL="1703710" indent="0">
              <a:buNone/>
              <a:defRPr sz="932"/>
            </a:lvl5pPr>
            <a:lvl6pPr marL="2129638" indent="0">
              <a:buNone/>
              <a:defRPr sz="932"/>
            </a:lvl6pPr>
            <a:lvl7pPr marL="2555565" indent="0">
              <a:buNone/>
              <a:defRPr sz="932"/>
            </a:lvl7pPr>
            <a:lvl8pPr marL="2981493" indent="0">
              <a:buNone/>
              <a:defRPr sz="932"/>
            </a:lvl8pPr>
            <a:lvl9pPr marL="3407420" indent="0">
              <a:buNone/>
              <a:defRPr sz="93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4773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80901" y="374000"/>
            <a:ext cx="9796761" cy="13577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0901" y="1869998"/>
            <a:ext cx="9796761" cy="44571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80901" y="6510845"/>
            <a:ext cx="2555677" cy="3740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1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62524" y="6510845"/>
            <a:ext cx="3833515" cy="3740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1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021985" y="6510845"/>
            <a:ext cx="2555677" cy="3740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1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498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851855" rtl="0" eaLnBrk="1" latinLnBrk="0" hangingPunct="1">
        <a:lnSpc>
          <a:spcPct val="90000"/>
        </a:lnSpc>
        <a:spcBef>
          <a:spcPct val="0"/>
        </a:spcBef>
        <a:buNone/>
        <a:defRPr sz="40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2964" indent="-212964" algn="l" defTabSz="851855" rtl="0" eaLnBrk="1" latinLnBrk="0" hangingPunct="1">
        <a:lnSpc>
          <a:spcPct val="90000"/>
        </a:lnSpc>
        <a:spcBef>
          <a:spcPts val="932"/>
        </a:spcBef>
        <a:buFont typeface="Arial" panose="020B0604020202020204" pitchFamily="34" charset="0"/>
        <a:buChar char="•"/>
        <a:defRPr sz="2608" kern="1200">
          <a:solidFill>
            <a:schemeClr val="tx1"/>
          </a:solidFill>
          <a:latin typeface="+mn-lt"/>
          <a:ea typeface="+mn-ea"/>
          <a:cs typeface="+mn-cs"/>
        </a:defRPr>
      </a:lvl1pPr>
      <a:lvl2pPr marL="638891" indent="-212964" algn="l" defTabSz="851855" rtl="0" eaLnBrk="1" latinLnBrk="0" hangingPunct="1">
        <a:lnSpc>
          <a:spcPct val="90000"/>
        </a:lnSpc>
        <a:spcBef>
          <a:spcPts val="466"/>
        </a:spcBef>
        <a:buFont typeface="Arial" panose="020B0604020202020204" pitchFamily="34" charset="0"/>
        <a:buChar char="•"/>
        <a:defRPr sz="2236" kern="1200">
          <a:solidFill>
            <a:schemeClr val="tx1"/>
          </a:solidFill>
          <a:latin typeface="+mn-lt"/>
          <a:ea typeface="+mn-ea"/>
          <a:cs typeface="+mn-cs"/>
        </a:defRPr>
      </a:lvl2pPr>
      <a:lvl3pPr marL="1064819" indent="-212964" algn="l" defTabSz="851855" rtl="0" eaLnBrk="1" latinLnBrk="0" hangingPunct="1">
        <a:lnSpc>
          <a:spcPct val="90000"/>
        </a:lnSpc>
        <a:spcBef>
          <a:spcPts val="466"/>
        </a:spcBef>
        <a:buFont typeface="Arial" panose="020B0604020202020204" pitchFamily="34" charset="0"/>
        <a:buChar char="•"/>
        <a:defRPr sz="1863" kern="1200">
          <a:solidFill>
            <a:schemeClr val="tx1"/>
          </a:solidFill>
          <a:latin typeface="+mn-lt"/>
          <a:ea typeface="+mn-ea"/>
          <a:cs typeface="+mn-cs"/>
        </a:defRPr>
      </a:lvl3pPr>
      <a:lvl4pPr marL="1490746" indent="-212964" algn="l" defTabSz="851855" rtl="0" eaLnBrk="1" latinLnBrk="0" hangingPunct="1">
        <a:lnSpc>
          <a:spcPct val="90000"/>
        </a:lnSpc>
        <a:spcBef>
          <a:spcPts val="466"/>
        </a:spcBef>
        <a:buFont typeface="Arial" panose="020B0604020202020204" pitchFamily="34" charset="0"/>
        <a:buChar char="•"/>
        <a:defRPr sz="1677" kern="1200">
          <a:solidFill>
            <a:schemeClr val="tx1"/>
          </a:solidFill>
          <a:latin typeface="+mn-lt"/>
          <a:ea typeface="+mn-ea"/>
          <a:cs typeface="+mn-cs"/>
        </a:defRPr>
      </a:lvl4pPr>
      <a:lvl5pPr marL="1916674" indent="-212964" algn="l" defTabSz="851855" rtl="0" eaLnBrk="1" latinLnBrk="0" hangingPunct="1">
        <a:lnSpc>
          <a:spcPct val="90000"/>
        </a:lnSpc>
        <a:spcBef>
          <a:spcPts val="466"/>
        </a:spcBef>
        <a:buFont typeface="Arial" panose="020B0604020202020204" pitchFamily="34" charset="0"/>
        <a:buChar char="•"/>
        <a:defRPr sz="1677" kern="1200">
          <a:solidFill>
            <a:schemeClr val="tx1"/>
          </a:solidFill>
          <a:latin typeface="+mn-lt"/>
          <a:ea typeface="+mn-ea"/>
          <a:cs typeface="+mn-cs"/>
        </a:defRPr>
      </a:lvl5pPr>
      <a:lvl6pPr marL="2342601" indent="-212964" algn="l" defTabSz="851855" rtl="0" eaLnBrk="1" latinLnBrk="0" hangingPunct="1">
        <a:lnSpc>
          <a:spcPct val="90000"/>
        </a:lnSpc>
        <a:spcBef>
          <a:spcPts val="466"/>
        </a:spcBef>
        <a:buFont typeface="Arial" panose="020B0604020202020204" pitchFamily="34" charset="0"/>
        <a:buChar char="•"/>
        <a:defRPr sz="1677" kern="1200">
          <a:solidFill>
            <a:schemeClr val="tx1"/>
          </a:solidFill>
          <a:latin typeface="+mn-lt"/>
          <a:ea typeface="+mn-ea"/>
          <a:cs typeface="+mn-cs"/>
        </a:defRPr>
      </a:lvl6pPr>
      <a:lvl7pPr marL="2768529" indent="-212964" algn="l" defTabSz="851855" rtl="0" eaLnBrk="1" latinLnBrk="0" hangingPunct="1">
        <a:lnSpc>
          <a:spcPct val="90000"/>
        </a:lnSpc>
        <a:spcBef>
          <a:spcPts val="466"/>
        </a:spcBef>
        <a:buFont typeface="Arial" panose="020B0604020202020204" pitchFamily="34" charset="0"/>
        <a:buChar char="•"/>
        <a:defRPr sz="1677" kern="1200">
          <a:solidFill>
            <a:schemeClr val="tx1"/>
          </a:solidFill>
          <a:latin typeface="+mn-lt"/>
          <a:ea typeface="+mn-ea"/>
          <a:cs typeface="+mn-cs"/>
        </a:defRPr>
      </a:lvl7pPr>
      <a:lvl8pPr marL="3194456" indent="-212964" algn="l" defTabSz="851855" rtl="0" eaLnBrk="1" latinLnBrk="0" hangingPunct="1">
        <a:lnSpc>
          <a:spcPct val="90000"/>
        </a:lnSpc>
        <a:spcBef>
          <a:spcPts val="466"/>
        </a:spcBef>
        <a:buFont typeface="Arial" panose="020B0604020202020204" pitchFamily="34" charset="0"/>
        <a:buChar char="•"/>
        <a:defRPr sz="1677" kern="1200">
          <a:solidFill>
            <a:schemeClr val="tx1"/>
          </a:solidFill>
          <a:latin typeface="+mn-lt"/>
          <a:ea typeface="+mn-ea"/>
          <a:cs typeface="+mn-cs"/>
        </a:defRPr>
      </a:lvl8pPr>
      <a:lvl9pPr marL="3620384" indent="-212964" algn="l" defTabSz="851855" rtl="0" eaLnBrk="1" latinLnBrk="0" hangingPunct="1">
        <a:lnSpc>
          <a:spcPct val="90000"/>
        </a:lnSpc>
        <a:spcBef>
          <a:spcPts val="466"/>
        </a:spcBef>
        <a:buFont typeface="Arial" panose="020B0604020202020204" pitchFamily="34" charset="0"/>
        <a:buChar char="•"/>
        <a:defRPr sz="167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1pPr>
      <a:lvl2pPr marL="425928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2pPr>
      <a:lvl3pPr marL="851855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3pPr>
      <a:lvl4pPr marL="1277783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4pPr>
      <a:lvl5pPr marL="1703710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5pPr>
      <a:lvl6pPr marL="2129638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6pPr>
      <a:lvl7pPr marL="2555565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7pPr>
      <a:lvl8pPr marL="2981493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8pPr>
      <a:lvl9pPr marL="3407420" algn="l" defTabSz="851855" rtl="0" eaLnBrk="1" latinLnBrk="0" hangingPunct="1">
        <a:defRPr sz="167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5202644"/>
              </p:ext>
            </p:extLst>
          </p:nvPr>
        </p:nvGraphicFramePr>
        <p:xfrm>
          <a:off x="243839" y="1132494"/>
          <a:ext cx="10869860" cy="5490576"/>
        </p:xfrm>
        <a:graphic>
          <a:graphicData uri="http://schemas.openxmlformats.org/drawingml/2006/table">
            <a:tbl>
              <a:tblPr firstRow="1" firstCol="1" bandRow="1"/>
              <a:tblGrid>
                <a:gridCol w="168681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5101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7652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800779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6570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7652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854886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822421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227248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833243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908992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865706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</a:tblGrid>
              <a:tr h="14075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Q-5D dimension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uring teriparatide treatment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fter teriparatide discontinued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72296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mont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 mont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 mont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 mont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 mont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 mont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 mont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 mont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4075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obility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4075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8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1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6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8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1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27311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10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problems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98 (4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97 (49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71 (55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7 (59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94 (63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82 (63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9 (7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6 (52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1 (76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36 (56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81 (48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6 (44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70 (4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91 (35.9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8 (35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3 (29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4 (46.9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5 (23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xtre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9 (3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 (1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 (0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 (0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 (0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4075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lf car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4075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7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1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6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8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1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27311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10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61 (65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65 (72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49 (78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31 (80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0 (82.9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47 (81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78 (86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7 (8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7 (84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me problems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55 (30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5 (25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3 (20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8 (18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3 (15.9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7 (17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2 (13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 (18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 (15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xtre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3 (4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 (2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 (1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 (1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 (1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 (1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0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 (1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4075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sual activities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4075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8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6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8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1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27311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10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57 (30.9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8 (45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92 (48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45 (55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38 (58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24 (57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3 (69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8 (50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0 (71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21 (55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6 (48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8 (45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69 (40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4 (37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38 (36.9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6 (30.0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9 (45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8 (26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xtre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3 (13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5 (6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 (5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 (4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7 (4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 (6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0.9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 (3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 (1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227311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in and discomfort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4075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8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6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8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1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27311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10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problems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6 (12.5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1 (21.8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5 (29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96 (34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8 (38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90 (42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0 (52.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5 (28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5 (5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4 (66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15 (68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90 (64.9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1 (60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16 (56.6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78 (52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0 (43.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2 (65.4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5 (46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xtre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15 (21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3 (1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3 (6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7 (5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 (5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 (5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 (4.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 (6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 (3.6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227311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xiety and depressio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4075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8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1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6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8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1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227311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10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39 (43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19 (51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75 (55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6 (56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6 (6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9 (63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36 (60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4 (60.4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3 (63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2273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98 (47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6 (42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2 (39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3 (38.1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4 (35.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5 (33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0 (36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9 (34.8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7 (33.1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9540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xtreme proble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4 (9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1 (5.9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 (4.7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3 (5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7 (4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 (3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 (3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 (4.9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 (3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27" marR="5852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1749" y="839515"/>
            <a:ext cx="9977948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ine Resource 5. </a:t>
            </a:r>
            <a:r>
              <a:rPr lang="en-GB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uroQol-5 dimension (EQ-5D) (Total Study Cohort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05294" y="6662898"/>
            <a:ext cx="10934531" cy="2308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9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umber of evaluable patients (denominator for percentages); </a:t>
            </a:r>
            <a:r>
              <a:rPr lang="en-GB" sz="9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umber of patients with characteristi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7FAD759-32C9-41A8-856C-BA4AC3A4AA16}"/>
              </a:ext>
            </a:extLst>
          </p:cNvPr>
          <p:cNvSpPr txBox="1"/>
          <p:nvPr/>
        </p:nvSpPr>
        <p:spPr>
          <a:xfrm>
            <a:off x="161749" y="203683"/>
            <a:ext cx="10921087" cy="58477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ffectiveness of teriparatide in patients with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osteoporosis in clinical practice: 42-month results during and after discontinuation of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treatment from the European Extended 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orsteo</a:t>
            </a:r>
            <a:r>
              <a:rPr lang="en-GB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Observational Study (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xFOS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Calcified Tissue International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. Napoli, B. L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Langdahl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Ö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Ljunggre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E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Lespessaille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G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Kapetano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T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Kocja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T. Nikolic, P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Eike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H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Petto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T. Moll, E. Lindh, F. Marin</a:t>
            </a:r>
          </a:p>
          <a:p>
            <a:pPr>
              <a:defRPr/>
            </a:pP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sponding author: Nicola Napoli,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University Campus Bio-Medico, Rome, Italy; e-mail: 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Napoli@unicampus.it</a:t>
            </a:r>
          </a:p>
        </p:txBody>
      </p:sp>
    </p:spTree>
    <p:extLst>
      <p:ext uri="{BB962C8B-B14F-4D97-AF65-F5344CB8AC3E}">
        <p14:creationId xmlns:p14="http://schemas.microsoft.com/office/powerpoint/2010/main" val="363528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814</Words>
  <Application>Microsoft Office PowerPoint</Application>
  <PresentationFormat>Custom</PresentationFormat>
  <Paragraphs>3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x</dc:creator>
  <cp:lastModifiedBy>Rx</cp:lastModifiedBy>
  <cp:revision>12</cp:revision>
  <dcterms:created xsi:type="dcterms:W3CDTF">2017-07-05T13:17:28Z</dcterms:created>
  <dcterms:modified xsi:type="dcterms:W3CDTF">2018-01-18T14:16:41Z</dcterms:modified>
</cp:coreProperties>
</file>